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9" d="100"/>
          <a:sy n="99" d="100"/>
        </p:scale>
        <p:origin x="354" y="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23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000" b="1" dirty="0">
                <a:solidFill>
                  <a:srgbClr val="000000"/>
                </a:solidFill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Prognostic Significance of Incidental Suspected Transthyretin Amyloidosis on Routine Bone Scintigraphy</a:t>
            </a:r>
            <a:endParaRPr lang="en-US" altLang="en-US" sz="8000" dirty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77000" cy="1524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Aft>
                <a:spcPts val="800"/>
              </a:spcAft>
            </a:pP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lli Suomalainen M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Jaagup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ilv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Antti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oimaala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D, Ph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orjo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ätzke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D, Ph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Verdana" panose="020B0604030504040204" pitchFamily="34" charset="0"/>
                <a:cs typeface="Times New Roman" panose="02020603050405020304" pitchFamily="18" charset="0"/>
              </a:rPr>
              <a:t>2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Tiina </a:t>
            </a:r>
            <a:r>
              <a:rPr lang="fi-FI" sz="14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Heliö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D, Ph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fi-FI" sz="14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Valtteri Uusitalo MD, PhD</a:t>
            </a:r>
            <a:r>
              <a:rPr lang="fi-FI" sz="1400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</a:p>
          <a:p>
            <a:pPr algn="l">
              <a:spcAft>
                <a:spcPts val="800"/>
              </a:spcAft>
            </a:pPr>
            <a:r>
              <a:rPr lang="en-US" sz="1400" i="1" baseline="300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i="1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Kymenlaakso Central Hospital, Department of Cardiology, </a:t>
            </a:r>
            <a:r>
              <a:rPr lang="en-US" sz="1400" i="1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Kotka</a:t>
            </a:r>
            <a:r>
              <a:rPr lang="en-US" sz="1400" i="1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Finland; </a:t>
            </a:r>
            <a:r>
              <a:rPr lang="en-US" sz="1400" i="1" baseline="30000" dirty="0">
                <a:solidFill>
                  <a:srgbClr val="000000"/>
                </a:solidFill>
                <a:effectLst/>
                <a:ea typeface="Verdana" panose="020B0604030504040204" pitchFamily="34" charset="0"/>
                <a:cs typeface="Times New Roman" panose="02020603050405020304" pitchFamily="18" charset="0"/>
              </a:rPr>
              <a:t>2</a:t>
            </a:r>
            <a:r>
              <a:rPr lang="en-US" sz="1400" i="1" dirty="0">
                <a:solidFill>
                  <a:srgbClr val="000000"/>
                </a:solidFill>
                <a:effectLst/>
                <a:ea typeface="Verdana" panose="020B0604030504040204" pitchFamily="34" charset="0"/>
                <a:cs typeface="Times New Roman" panose="02020603050405020304" pitchFamily="18" charset="0"/>
              </a:rPr>
              <a:t>Clinical physiology and Nuclear Medicine, Helsinki University Hospital and University of Helsinki, Finland; </a:t>
            </a:r>
            <a:r>
              <a:rPr lang="en-US" sz="1400" i="1" baseline="30000" dirty="0">
                <a:solidFill>
                  <a:srgbClr val="000000"/>
                </a:solidFill>
                <a:effectLst/>
                <a:ea typeface="Verdana" panose="020B0604030504040204" pitchFamily="34" charset="0"/>
                <a:cs typeface="Times New Roman" panose="02020603050405020304" pitchFamily="18" charset="0"/>
              </a:rPr>
              <a:t>3</a:t>
            </a:r>
            <a:r>
              <a:rPr lang="en-US" sz="1400" i="1" dirty="0">
                <a:solidFill>
                  <a:srgbClr val="000000"/>
                </a:solidFill>
                <a:effectLst/>
                <a:ea typeface="Verdana" panose="020B0604030504040204" pitchFamily="34" charset="0"/>
                <a:cs typeface="Times New Roman" panose="02020603050405020304" pitchFamily="18" charset="0"/>
              </a:rPr>
              <a:t>Heart and Lung Center, Helsinki University Hospital and University of Helsinki, Finland</a:t>
            </a:r>
            <a:endParaRPr lang="en-US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Kuva 1">
            <a:extLst>
              <a:ext uri="{FF2B5EF4-FFF2-40B4-BE49-F238E27FC236}">
                <a16:creationId xmlns:a16="http://schemas.microsoft.com/office/drawing/2014/main" id="{60155786-02C9-4088-A1BD-BD7D61032591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8657" y="4587339"/>
            <a:ext cx="1610463" cy="8151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E55DCB3-30A0-4D8C-86E8-7FC0DDC872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9963" y="4232909"/>
            <a:ext cx="1775381" cy="1524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52600"/>
            <a:ext cx="8305800" cy="41513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28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Transthyretin amyloidosis (ATTR) is an occasional incidental finding on routine bone scintigraphy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8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 studied the prognostic impact of incidental HMDP cardiac uptake in elderly patients</a:t>
            </a: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11287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r>
              <a:rPr lang="en-US" altLang="en-US" sz="2400" dirty="0"/>
              <a:t> </a:t>
            </a:r>
          </a:p>
          <a:p>
            <a:pPr marL="400050" lvl="1" indent="0">
              <a:buNone/>
            </a:pPr>
            <a:r>
              <a:rPr lang="en-US" altLang="en-US" sz="2400" dirty="0"/>
              <a:t>Retrospective observational coho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</a:p>
          <a:p>
            <a:pPr marL="400050" lvl="1" indent="0">
              <a:buNone/>
            </a:pPr>
            <a:r>
              <a:rPr lang="en-US" altLang="en-US" sz="2400" dirty="0"/>
              <a:t>2000 patients older than 70 years who underwent bone scintigraphy due to non-cardiac indication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400" dirty="0"/>
              <a:t>Primary end point: Total mortality</a:t>
            </a:r>
          </a:p>
          <a:p>
            <a:pPr marL="400050" lvl="1" indent="0">
              <a:buNone/>
            </a:pPr>
            <a:r>
              <a:rPr lang="en-US" altLang="en-US" sz="2400" dirty="0"/>
              <a:t>Secondary end point: Cardiovascular mortalit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</a:p>
          <a:p>
            <a:pPr marL="400050" lvl="1" indent="0">
              <a:buNone/>
            </a:pPr>
            <a:r>
              <a:rPr lang="en-US" altLang="en-US" sz="2400" dirty="0"/>
              <a:t>Visual analysis of cardiac uptake (</a:t>
            </a:r>
            <a:r>
              <a:rPr lang="en-US" altLang="en-US" sz="2400" i="1" dirty="0" err="1"/>
              <a:t>Perugini</a:t>
            </a:r>
            <a:r>
              <a:rPr lang="en-US" altLang="en-US" sz="2400" i="1" dirty="0"/>
              <a:t> grade</a:t>
            </a:r>
            <a:r>
              <a:rPr lang="en-US" altLang="en-US" sz="2400" dirty="0"/>
              <a:t>)</a:t>
            </a:r>
          </a:p>
          <a:p>
            <a:pPr marL="400050" lvl="1" indent="0">
              <a:buNone/>
            </a:pPr>
            <a:r>
              <a:rPr lang="en-US" altLang="en-US" sz="2400" dirty="0"/>
              <a:t>Heart-to-contralateral ratio (H/CL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6A75FB0D-8D56-43F6-B5FD-DE714747BCE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844" y="1481834"/>
            <a:ext cx="4329490" cy="3247118"/>
          </a:xfrm>
          <a:prstGeom prst="rect">
            <a:avLst/>
          </a:prstGeom>
        </p:spPr>
      </p:pic>
      <p:pic>
        <p:nvPicPr>
          <p:cNvPr id="6" name="Picture 5" descr="A close up of a map&#10;&#10;Description automatically generated">
            <a:extLst>
              <a:ext uri="{FF2B5EF4-FFF2-40B4-BE49-F238E27FC236}">
                <a16:creationId xmlns:a16="http://schemas.microsoft.com/office/drawing/2014/main" id="{FF96BD5A-619F-4E09-98BB-62C0118AFEF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1467" y="1481137"/>
            <a:ext cx="4425950" cy="3319463"/>
          </a:xfrm>
          <a:prstGeom prst="rect">
            <a:avLst/>
          </a:prstGeom>
        </p:spPr>
      </p:pic>
      <p:sp>
        <p:nvSpPr>
          <p:cNvPr id="15" name="Content Placeholder 14">
            <a:extLst>
              <a:ext uri="{FF2B5EF4-FFF2-40B4-BE49-F238E27FC236}">
                <a16:creationId xmlns:a16="http://schemas.microsoft.com/office/drawing/2014/main" id="{465DA6B4-398D-4772-9630-73338B6B6E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4876800"/>
            <a:ext cx="8229600" cy="1080719"/>
          </a:xfrm>
        </p:spPr>
        <p:txBody>
          <a:bodyPr/>
          <a:lstStyle/>
          <a:p>
            <a:pPr marL="0" indent="0">
              <a:buNone/>
            </a:pP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ncidental myocardial uptake on bone scintigraphy and patient prognosis. Overall mortality in patients with different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erugini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grades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myocardial uptake; no uptake (grade 0), lower than bone (grade 1), equal to bone (grade 2) and higher than bone uptake (grade 3) (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. Cardiovascular mortality according to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erugini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grade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.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Picture 11" descr="A close up of a map&#10;&#10;Description automatically generated">
            <a:extLst>
              <a:ext uri="{FF2B5EF4-FFF2-40B4-BE49-F238E27FC236}">
                <a16:creationId xmlns:a16="http://schemas.microsoft.com/office/drawing/2014/main" id="{0AACC2E1-C931-4B97-B9C4-F481C2EC04C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800" y="1633537"/>
            <a:ext cx="4527552" cy="3395664"/>
          </a:xfrm>
          <a:prstGeom prst="rect">
            <a:avLst/>
          </a:prstGeom>
        </p:spPr>
      </p:pic>
      <p:pic>
        <p:nvPicPr>
          <p:cNvPr id="18" name="Content Placeholder 17" descr="A close up of a map&#10;&#10;Description automatically generated">
            <a:extLst>
              <a:ext uri="{FF2B5EF4-FFF2-40B4-BE49-F238E27FC236}">
                <a16:creationId xmlns:a16="http://schemas.microsoft.com/office/drawing/2014/main" id="{9FFFE914-B13D-439B-AB45-0E83CB58364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" y="1600199"/>
            <a:ext cx="4587559" cy="3440669"/>
          </a:xfr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DCB29DE-2173-4C04-992A-CE82E06E4D1A}"/>
              </a:ext>
            </a:extLst>
          </p:cNvPr>
          <p:cNvSpPr txBox="1"/>
          <p:nvPr/>
        </p:nvSpPr>
        <p:spPr>
          <a:xfrm>
            <a:off x="304800" y="14478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dirty="0"/>
              <a:t>A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65ACBD2-25B8-4EF7-8B42-DA55129607F8}"/>
              </a:ext>
            </a:extLst>
          </p:cNvPr>
          <p:cNvSpPr txBox="1"/>
          <p:nvPr/>
        </p:nvSpPr>
        <p:spPr>
          <a:xfrm>
            <a:off x="4714875" y="145946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dirty="0"/>
              <a:t>B</a:t>
            </a:r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5B90A10-0D20-4D34-9AE1-5BA18CAFCA85}"/>
              </a:ext>
            </a:extLst>
          </p:cNvPr>
          <p:cNvSpPr txBox="1"/>
          <p:nvPr/>
        </p:nvSpPr>
        <p:spPr>
          <a:xfrm>
            <a:off x="381000" y="5058647"/>
            <a:ext cx="843370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verall mortality (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and cardiac mortality (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in patients with suspected incidental finding of transthyretin amyloidosis (ATTR) by quantitative heart-to-contralateral ratio (H/CL) analysis. H/CL threshold of </a:t>
            </a:r>
            <a:r>
              <a:rPr lang="en-US" sz="18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&gt;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.30 has been previously shown to be diagnostic to ATTR in three-hour imaging protocol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28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spected ATTR on routine bone scintigraphy is associated with elevated risk of overall and cardiovascular mortality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8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urther clinical evaluation of incidental cardiac uptake on bone scintigraphy is warranted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sz="28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Quantitative H/CL ratio offers additional risk stratification of an incidental cardiac uptake on bone scintigraphy compared to visual analysis alone.</a:t>
            </a:r>
            <a:endParaRPr lang="en-US" sz="28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Words>470</Words>
  <Application>Microsoft Office PowerPoint</Application>
  <PresentationFormat>On-screen Show (4:3)</PresentationFormat>
  <Paragraphs>4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Prognostic Significance of Incidental Suspected Transthyretin Amyloidosis on Routine Bone Scintigraph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Valtteri Uusitalo</cp:lastModifiedBy>
  <cp:revision>105</cp:revision>
  <dcterms:created xsi:type="dcterms:W3CDTF">2011-04-18T21:44:13Z</dcterms:created>
  <dcterms:modified xsi:type="dcterms:W3CDTF">2020-08-23T06:02:48Z</dcterms:modified>
</cp:coreProperties>
</file>